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 snapToObjects="1">
      <p:cViewPr varScale="1">
        <p:scale>
          <a:sx n="92" d="100"/>
          <a:sy n="92" d="100"/>
        </p:scale>
        <p:origin x="20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EEE81-A419-0847-8336-5E313C9E2F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7DCE9C-023C-B340-A15F-8DC2052BEA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CE181F-B851-6940-975B-BA9DDBD68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B5354-DF3B-E64F-9675-091FFB8E9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0F77E-845F-554D-ABD2-08FA60CBA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024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734B63-C81B-514B-B459-5247F18E5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BFD797-C359-C443-A461-A464ACEE08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C1E6D1-61B5-8E46-8F17-DC7A23DA7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9FE68-C59E-B84A-9313-27EA3CE40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E1E8C-3ADD-364D-8DD4-79F9BFB40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16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2F224E9-A3D7-3340-8550-ECA67AB9EA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314307-89EC-7F41-AAF0-7E671EB418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656D3-9F17-0446-9F0B-B0D3D186B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CF3966-B02C-DF42-A689-22EF56429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46E2C-D6C1-9E4B-8E7F-97ABBEB0EB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75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5B36A-2F92-8747-8074-272A90F0E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736094-0B71-3D4E-BA70-A04E356ECE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BD228C-E50B-D44A-A1AC-571E1BAB0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26A71-E058-AE49-91F5-F7F51B71D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3BEE2F-FFAD-9244-93C7-43B7354F4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646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94558-152E-9141-9F15-4ECF4914F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4EF663-5EDF-0D41-AEC9-6DDD52EF62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FDD47E-1351-2F42-952C-06681D08A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55F43-1D13-2948-AFF8-1BD0018AE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89E470-2DFC-C349-8B9F-2B937CED9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8174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C9739-C90C-A44D-9101-CD7649FEF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35FA7F-16DA-AA45-9AB8-0E5515A404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B7BDAA-5B57-5446-9BD0-15B3031521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F5DAA9-019D-F741-84F5-F564C8A03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760D21-85FA-2947-BF87-A87A167C9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98CDC2-62F8-D545-BD1B-CEE64FDDC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81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B60C6C-7A7E-2A4B-8EBE-5F2E2931C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B56FF4-7CD1-4E4C-92A4-F813055C2F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C92D8B-AAA5-944B-B055-EB22B4C9A6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8118FA-C14B-454E-BF0F-F687AFB370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7872FB-5310-E94B-B0A0-CBF6BF7158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7F91C3-1978-0846-B395-03B36F16C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3AC395-6DAF-6E4A-9554-435B09DED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EB5A21-D948-8E43-A0C0-C5A8DB096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164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D7493-7332-4D4C-99AD-F9B4C85700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2630C1-62DD-A042-9B69-4697D374C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45165-CDD6-204F-8BDF-4494A5575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87F3FE-C509-2B49-9151-AF3521A1A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994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20E459-67BD-B44A-A3C8-9FA5CB20D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E2B7E7-6D0F-F243-9613-43C8DB909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C56A10-5A35-D849-883C-79F9CE4AB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116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E6C09-7F05-2D41-BBBC-114C2ED871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96B0EF-EA72-8E4F-98FF-06AE44F53D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2334CB-5463-274C-8EBB-FBBA927821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FD45F1-292D-494E-A2DC-20E65D3E4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CE4C4B-B616-AC48-89D6-F74F043B0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840AF6-EE40-C044-947F-08F7DA2D4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769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D97BD-2AF2-934B-A74E-691CF49F8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01331B-7795-B246-B784-25FD668C2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68A1F6-725C-F24C-B7DB-A368C35AFA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BF1FF2-B904-4844-807E-1695B80DE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1A2811-0586-894F-8CC5-BE81C40D9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850285-31FE-074F-B04F-8F0373391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403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9F9956-E735-B643-BFCC-96F7A2AF0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B948F3-7C10-6949-B1E1-88597B6479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3F9CF0-2184-A641-B1B1-CDC9B2E876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FC124-4B03-2D42-A229-7BD24304E4F6}" type="datetimeFigureOut">
              <a:rPr lang="en-US" smtClean="0"/>
              <a:t>6/28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A36E8-F959-5D4F-8B24-5BF0ED11C2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B0E78B-7745-084B-9214-6336DD1EAE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081E4-D701-A748-88FD-B4D37EF2D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741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12.png"/><Relationship Id="rId3" Type="http://schemas.openxmlformats.org/officeDocument/2006/relationships/image" Target="../media/image2.svg"/><Relationship Id="rId7" Type="http://schemas.openxmlformats.org/officeDocument/2006/relationships/image" Target="../media/image6.png"/><Relationship Id="rId12" Type="http://schemas.openxmlformats.org/officeDocument/2006/relationships/image" Target="../media/image11.svg"/><Relationship Id="rId2" Type="http://schemas.openxmlformats.org/officeDocument/2006/relationships/image" Target="../media/image1.pn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svg"/><Relationship Id="rId15" Type="http://schemas.openxmlformats.org/officeDocument/2006/relationships/image" Target="../media/image14.tiff"/><Relationship Id="rId10" Type="http://schemas.openxmlformats.org/officeDocument/2006/relationships/image" Target="../media/image9.sv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BC300679-5DEF-724E-955A-B71D17346DC7}"/>
              </a:ext>
            </a:extLst>
          </p:cNvPr>
          <p:cNvCxnSpPr>
            <a:cxnSpLocks/>
          </p:cNvCxnSpPr>
          <p:nvPr/>
        </p:nvCxnSpPr>
        <p:spPr>
          <a:xfrm>
            <a:off x="10951631" y="4011366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93E3BB96-ED86-9048-A51D-E8F91D03E42E}"/>
              </a:ext>
            </a:extLst>
          </p:cNvPr>
          <p:cNvCxnSpPr>
            <a:cxnSpLocks/>
          </p:cNvCxnSpPr>
          <p:nvPr/>
        </p:nvCxnSpPr>
        <p:spPr>
          <a:xfrm>
            <a:off x="5724405" y="3971474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6D0BCE65-1784-8847-AD16-19E05F915071}"/>
              </a:ext>
            </a:extLst>
          </p:cNvPr>
          <p:cNvCxnSpPr>
            <a:cxnSpLocks/>
          </p:cNvCxnSpPr>
          <p:nvPr/>
        </p:nvCxnSpPr>
        <p:spPr>
          <a:xfrm>
            <a:off x="1755141" y="4011367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74A3548B-CE1B-2B45-9289-E15C4C22E116}"/>
              </a:ext>
            </a:extLst>
          </p:cNvPr>
          <p:cNvSpPr/>
          <p:nvPr/>
        </p:nvSpPr>
        <p:spPr>
          <a:xfrm>
            <a:off x="1764262" y="2466199"/>
            <a:ext cx="9139664" cy="484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Intervention Group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9D1A005-8049-9640-9C32-9D5D7976AC21}"/>
              </a:ext>
            </a:extLst>
          </p:cNvPr>
          <p:cNvSpPr/>
          <p:nvPr/>
        </p:nvSpPr>
        <p:spPr>
          <a:xfrm>
            <a:off x="1765579" y="4241638"/>
            <a:ext cx="9186785" cy="4849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Comparison Group (Assessment only)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B1F1C72-D63E-9145-81F6-C62B87576595}"/>
              </a:ext>
            </a:extLst>
          </p:cNvPr>
          <p:cNvCxnSpPr>
            <a:cxnSpLocks/>
          </p:cNvCxnSpPr>
          <p:nvPr/>
        </p:nvCxnSpPr>
        <p:spPr>
          <a:xfrm>
            <a:off x="1764262" y="2022764"/>
            <a:ext cx="91224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8BDE649-9180-A44D-A960-04E94A94D809}"/>
              </a:ext>
            </a:extLst>
          </p:cNvPr>
          <p:cNvCxnSpPr/>
          <p:nvPr/>
        </p:nvCxnSpPr>
        <p:spPr>
          <a:xfrm>
            <a:off x="1764262" y="1641319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92887CD-5CC1-6541-9647-ED38AE4132CA}"/>
              </a:ext>
            </a:extLst>
          </p:cNvPr>
          <p:cNvCxnSpPr/>
          <p:nvPr/>
        </p:nvCxnSpPr>
        <p:spPr>
          <a:xfrm>
            <a:off x="10886754" y="1620982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B5BFA63-CA18-EB40-9D9E-409637DD9995}"/>
              </a:ext>
            </a:extLst>
          </p:cNvPr>
          <p:cNvCxnSpPr/>
          <p:nvPr/>
        </p:nvCxnSpPr>
        <p:spPr>
          <a:xfrm>
            <a:off x="3017372" y="1620981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2B582EA-AA8E-0D48-9A70-71674DF7830A}"/>
              </a:ext>
            </a:extLst>
          </p:cNvPr>
          <p:cNvCxnSpPr/>
          <p:nvPr/>
        </p:nvCxnSpPr>
        <p:spPr>
          <a:xfrm>
            <a:off x="5732862" y="1593274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9883F13-E264-094E-A2A5-93819F81CFEC}"/>
              </a:ext>
            </a:extLst>
          </p:cNvPr>
          <p:cNvCxnSpPr/>
          <p:nvPr/>
        </p:nvCxnSpPr>
        <p:spPr>
          <a:xfrm>
            <a:off x="7464681" y="1593273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AFB37E8-256E-A249-82BC-0E01C57C6D50}"/>
              </a:ext>
            </a:extLst>
          </p:cNvPr>
          <p:cNvSpPr txBox="1"/>
          <p:nvPr/>
        </p:nvSpPr>
        <p:spPr>
          <a:xfrm>
            <a:off x="1435007" y="2132529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ep, 201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BB62671-B8E4-F74A-BD9A-586B4EC64BBF}"/>
              </a:ext>
            </a:extLst>
          </p:cNvPr>
          <p:cNvSpPr txBox="1"/>
          <p:nvPr/>
        </p:nvSpPr>
        <p:spPr>
          <a:xfrm>
            <a:off x="2677935" y="2141003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Oct, 201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6FCC3F4-3579-FB49-B57F-B65D96DD043A}"/>
              </a:ext>
            </a:extLst>
          </p:cNvPr>
          <p:cNvSpPr txBox="1"/>
          <p:nvPr/>
        </p:nvSpPr>
        <p:spPr>
          <a:xfrm>
            <a:off x="5384339" y="2133362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ay, 201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0D0FAEB-2522-4747-BE74-BDF09C7DA79B}"/>
              </a:ext>
            </a:extLst>
          </p:cNvPr>
          <p:cNvSpPr txBox="1"/>
          <p:nvPr/>
        </p:nvSpPr>
        <p:spPr>
          <a:xfrm>
            <a:off x="10466041" y="2158858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ay, 201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9AADAFD-A7E3-1746-B249-238E71FD947F}"/>
              </a:ext>
            </a:extLst>
          </p:cNvPr>
          <p:cNvSpPr txBox="1"/>
          <p:nvPr/>
        </p:nvSpPr>
        <p:spPr>
          <a:xfrm>
            <a:off x="7104465" y="2146738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ug, 2016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3644C6E-3838-7F49-B452-9A5D8A7D9F97}"/>
              </a:ext>
            </a:extLst>
          </p:cNvPr>
          <p:cNvCxnSpPr/>
          <p:nvPr/>
        </p:nvCxnSpPr>
        <p:spPr>
          <a:xfrm>
            <a:off x="8977875" y="1593273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Graphic 28" descr="Soccer">
            <a:extLst>
              <a:ext uri="{FF2B5EF4-FFF2-40B4-BE49-F238E27FC236}">
                <a16:creationId xmlns:a16="http://schemas.microsoft.com/office/drawing/2014/main" id="{C90D385D-3E01-A645-A77A-6627B524C5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792998" y="1700178"/>
            <a:ext cx="356151" cy="356151"/>
          </a:xfrm>
          <a:prstGeom prst="rect">
            <a:avLst/>
          </a:prstGeom>
        </p:spPr>
      </p:pic>
      <p:pic>
        <p:nvPicPr>
          <p:cNvPr id="30" name="Graphic 29" descr="Soccer">
            <a:extLst>
              <a:ext uri="{FF2B5EF4-FFF2-40B4-BE49-F238E27FC236}">
                <a16:creationId xmlns:a16="http://schemas.microsoft.com/office/drawing/2014/main" id="{EE33D00C-A62B-394E-9530-01076E14B1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7503966" y="1639904"/>
            <a:ext cx="350193" cy="35019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41216A4-D358-B54C-9F49-65474C88A624}"/>
              </a:ext>
            </a:extLst>
          </p:cNvPr>
          <p:cNvSpPr txBox="1"/>
          <p:nvPr/>
        </p:nvSpPr>
        <p:spPr>
          <a:xfrm>
            <a:off x="0" y="1542984"/>
            <a:ext cx="13903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accent1">
                    <a:lumMod val="75000"/>
                  </a:schemeClr>
                </a:solidFill>
              </a:rPr>
              <a:t>Intervention Timeli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4DA8287-149C-644D-937C-2709B031C73F}"/>
              </a:ext>
            </a:extLst>
          </p:cNvPr>
          <p:cNvSpPr txBox="1"/>
          <p:nvPr/>
        </p:nvSpPr>
        <p:spPr>
          <a:xfrm>
            <a:off x="8657953" y="2152881"/>
            <a:ext cx="87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Oct, 201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A491517-82CF-FF4D-B57A-1D5888981F9A}"/>
              </a:ext>
            </a:extLst>
          </p:cNvPr>
          <p:cNvSpPr txBox="1"/>
          <p:nvPr/>
        </p:nvSpPr>
        <p:spPr>
          <a:xfrm>
            <a:off x="2063284" y="1737335"/>
            <a:ext cx="1121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1">
                    <a:lumMod val="75000"/>
                  </a:schemeClr>
                </a:solidFill>
              </a:rPr>
              <a:t>Soccer Cam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7A982E4-58B4-6149-92AF-25B72D254C50}"/>
              </a:ext>
            </a:extLst>
          </p:cNvPr>
          <p:cNvSpPr txBox="1"/>
          <p:nvPr/>
        </p:nvSpPr>
        <p:spPr>
          <a:xfrm>
            <a:off x="7802033" y="1682829"/>
            <a:ext cx="995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1">
                    <a:lumMod val="75000"/>
                  </a:schemeClr>
                </a:solidFill>
              </a:rPr>
              <a:t>Soccer Camp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B0DB1F-54DB-3D42-85B9-5EF2A55B1AED}"/>
              </a:ext>
            </a:extLst>
          </p:cNvPr>
          <p:cNvSpPr txBox="1"/>
          <p:nvPr/>
        </p:nvSpPr>
        <p:spPr>
          <a:xfrm>
            <a:off x="-27482" y="3092092"/>
            <a:ext cx="13903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accent1">
                    <a:lumMod val="75000"/>
                  </a:schemeClr>
                </a:solidFill>
              </a:rPr>
              <a:t>Assessment Timeline</a:t>
            </a:r>
          </a:p>
        </p:txBody>
      </p:sp>
      <p:pic>
        <p:nvPicPr>
          <p:cNvPr id="50" name="Graphic 49" descr="Ruler">
            <a:extLst>
              <a:ext uri="{FF2B5EF4-FFF2-40B4-BE49-F238E27FC236}">
                <a16:creationId xmlns:a16="http://schemas.microsoft.com/office/drawing/2014/main" id="{0C2BB98A-DA3C-8044-9FE9-45B00A33D9C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00423" y="3167738"/>
            <a:ext cx="433485" cy="433485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14A412DA-9812-DE4A-82CA-65D9BB81A915}"/>
              </a:ext>
            </a:extLst>
          </p:cNvPr>
          <p:cNvSpPr txBox="1"/>
          <p:nvPr/>
        </p:nvSpPr>
        <p:spPr>
          <a:xfrm>
            <a:off x="1382887" y="3572210"/>
            <a:ext cx="8728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Time 1 (Baseline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AC462B0-F011-384D-98D3-E3C097E8E844}"/>
              </a:ext>
            </a:extLst>
          </p:cNvPr>
          <p:cNvSpPr txBox="1"/>
          <p:nvPr/>
        </p:nvSpPr>
        <p:spPr>
          <a:xfrm>
            <a:off x="5265020" y="3549702"/>
            <a:ext cx="9921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Time 2 </a:t>
            </a:r>
          </a:p>
          <a:p>
            <a:pPr algn="ctr"/>
            <a:r>
              <a:rPr lang="en-US" sz="1200" b="1" dirty="0"/>
              <a:t>(Year 1 Exit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883131E-CDAB-7D45-8181-C453C4F8BCAD}"/>
              </a:ext>
            </a:extLst>
          </p:cNvPr>
          <p:cNvSpPr txBox="1"/>
          <p:nvPr/>
        </p:nvSpPr>
        <p:spPr>
          <a:xfrm>
            <a:off x="10436964" y="3632296"/>
            <a:ext cx="9921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Time 3</a:t>
            </a:r>
          </a:p>
          <a:p>
            <a:pPr algn="ctr"/>
            <a:r>
              <a:rPr lang="en-US" sz="1200" b="1" dirty="0"/>
              <a:t>(Year 2 Exit)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F2EE42F6-C327-0C4A-A0CE-4E0F6CDC2AAF}"/>
              </a:ext>
            </a:extLst>
          </p:cNvPr>
          <p:cNvCxnSpPr/>
          <p:nvPr/>
        </p:nvCxnSpPr>
        <p:spPr>
          <a:xfrm>
            <a:off x="193964" y="4890655"/>
            <a:ext cx="1166335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1FE78284-F16C-1540-8506-27DE0D0B7227}"/>
              </a:ext>
            </a:extLst>
          </p:cNvPr>
          <p:cNvSpPr txBox="1"/>
          <p:nvPr/>
        </p:nvSpPr>
        <p:spPr>
          <a:xfrm>
            <a:off x="8082" y="5168248"/>
            <a:ext cx="1196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Legend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A28C99A-0C12-4644-A25D-99276A575314}"/>
              </a:ext>
            </a:extLst>
          </p:cNvPr>
          <p:cNvSpPr txBox="1"/>
          <p:nvPr/>
        </p:nvSpPr>
        <p:spPr>
          <a:xfrm>
            <a:off x="2026070" y="5162379"/>
            <a:ext cx="1209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ports Nutrition lesson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BABA065-C92C-3948-89E2-63996541642D}"/>
              </a:ext>
            </a:extLst>
          </p:cNvPr>
          <p:cNvSpPr txBox="1"/>
          <p:nvPr/>
        </p:nvSpPr>
        <p:spPr>
          <a:xfrm>
            <a:off x="3741660" y="5071290"/>
            <a:ext cx="1317676" cy="642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eam Building Workshop (TBW)- Grocery Shopping</a:t>
            </a:r>
          </a:p>
        </p:txBody>
      </p:sp>
      <p:pic>
        <p:nvPicPr>
          <p:cNvPr id="80" name="Graphic 79" descr="Ruler">
            <a:extLst>
              <a:ext uri="{FF2B5EF4-FFF2-40B4-BE49-F238E27FC236}">
                <a16:creationId xmlns:a16="http://schemas.microsoft.com/office/drawing/2014/main" id="{DFDF51E3-EF9F-044D-B051-BBDD13CA55A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334644" y="5163734"/>
            <a:ext cx="433485" cy="433485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88A0E8E7-DEEE-9B4C-B0C8-A83656FB58B2}"/>
              </a:ext>
            </a:extLst>
          </p:cNvPr>
          <p:cNvSpPr txBox="1"/>
          <p:nvPr/>
        </p:nvSpPr>
        <p:spPr>
          <a:xfrm>
            <a:off x="5732862" y="5117728"/>
            <a:ext cx="1209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nthropometry Measurements</a:t>
            </a: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74F2F796-741D-BB47-9086-F0CD899B03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89058" y="5155110"/>
            <a:ext cx="468934" cy="468934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BEEDF50B-4EFA-284B-AB6B-A80F391CB8FF}"/>
              </a:ext>
            </a:extLst>
          </p:cNvPr>
          <p:cNvSpPr txBox="1"/>
          <p:nvPr/>
        </p:nvSpPr>
        <p:spPr>
          <a:xfrm>
            <a:off x="7885336" y="5125676"/>
            <a:ext cx="13734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Questionnaires:</a:t>
            </a:r>
          </a:p>
          <a:p>
            <a:r>
              <a:rPr lang="en-US" sz="1200" dirty="0"/>
              <a:t>1. Sports Nutrition 2. Block Food Frequency </a:t>
            </a:r>
          </a:p>
          <a:p>
            <a:r>
              <a:rPr lang="en-US" sz="1200" dirty="0"/>
              <a:t>3. Demographic</a:t>
            </a:r>
          </a:p>
        </p:txBody>
      </p:sp>
      <p:pic>
        <p:nvPicPr>
          <p:cNvPr id="84" name="Graphic 83" descr="Footprint">
            <a:extLst>
              <a:ext uri="{FF2B5EF4-FFF2-40B4-BE49-F238E27FC236}">
                <a16:creationId xmlns:a16="http://schemas.microsoft.com/office/drawing/2014/main" id="{64313815-9442-044F-9BDF-EC412D4C161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406293" y="5067130"/>
            <a:ext cx="524244" cy="524244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6F51DF15-ECEA-0545-8883-7F508D110DC8}"/>
              </a:ext>
            </a:extLst>
          </p:cNvPr>
          <p:cNvSpPr txBox="1"/>
          <p:nvPr/>
        </p:nvSpPr>
        <p:spPr>
          <a:xfrm>
            <a:off x="9956717" y="5098419"/>
            <a:ext cx="12092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7-Day Physical Activity Tracking with Fitbit</a:t>
            </a:r>
          </a:p>
        </p:txBody>
      </p:sp>
      <p:pic>
        <p:nvPicPr>
          <p:cNvPr id="3" name="Graphic 2" descr="Plant">
            <a:extLst>
              <a:ext uri="{FF2B5EF4-FFF2-40B4-BE49-F238E27FC236}">
                <a16:creationId xmlns:a16="http://schemas.microsoft.com/office/drawing/2014/main" id="{FA7E5E39-E717-8B46-B34D-CF7B932C3B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8760710" y="937294"/>
            <a:ext cx="515264" cy="515264"/>
          </a:xfrm>
          <a:prstGeom prst="rect">
            <a:avLst/>
          </a:prstGeom>
        </p:spPr>
      </p:pic>
      <p:pic>
        <p:nvPicPr>
          <p:cNvPr id="16" name="Graphic 15" descr="Shopping cart">
            <a:extLst>
              <a:ext uri="{FF2B5EF4-FFF2-40B4-BE49-F238E27FC236}">
                <a16:creationId xmlns:a16="http://schemas.microsoft.com/office/drawing/2014/main" id="{782AD749-FA7F-DB49-B31E-C31ACFBB509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2891753" y="924772"/>
            <a:ext cx="560347" cy="560347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id="{64247753-151F-7644-B491-DED1E121E569}"/>
              </a:ext>
            </a:extLst>
          </p:cNvPr>
          <p:cNvSpPr txBox="1"/>
          <p:nvPr/>
        </p:nvSpPr>
        <p:spPr>
          <a:xfrm>
            <a:off x="3796684" y="5794811"/>
            <a:ext cx="1317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BW-Cooking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C29D533-C02F-514F-924B-70ECC7EAC300}"/>
              </a:ext>
            </a:extLst>
          </p:cNvPr>
          <p:cNvSpPr txBox="1"/>
          <p:nvPr/>
        </p:nvSpPr>
        <p:spPr>
          <a:xfrm>
            <a:off x="3819573" y="6341421"/>
            <a:ext cx="1317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BW-Gardening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3BB63A1-A5DD-6C42-9BF4-9C5446F67931}"/>
              </a:ext>
            </a:extLst>
          </p:cNvPr>
          <p:cNvSpPr txBox="1"/>
          <p:nvPr/>
        </p:nvSpPr>
        <p:spPr>
          <a:xfrm>
            <a:off x="10062446" y="5999018"/>
            <a:ext cx="1209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nd of the Program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9EF4D9-B90C-4E47-B8B2-644848DA0527}"/>
              </a:ext>
            </a:extLst>
          </p:cNvPr>
          <p:cNvCxnSpPr>
            <a:cxnSpLocks/>
          </p:cNvCxnSpPr>
          <p:nvPr/>
        </p:nvCxnSpPr>
        <p:spPr>
          <a:xfrm>
            <a:off x="1764262" y="3183999"/>
            <a:ext cx="91396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BFC49F1-5B00-E844-BDAE-3E77BA3CF153}"/>
              </a:ext>
            </a:extLst>
          </p:cNvPr>
          <p:cNvCxnSpPr>
            <a:cxnSpLocks/>
          </p:cNvCxnSpPr>
          <p:nvPr/>
        </p:nvCxnSpPr>
        <p:spPr>
          <a:xfrm>
            <a:off x="1764262" y="3031599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C8EEC57-7CF6-1441-9F53-6BA4B39C9096}"/>
              </a:ext>
            </a:extLst>
          </p:cNvPr>
          <p:cNvCxnSpPr>
            <a:cxnSpLocks/>
          </p:cNvCxnSpPr>
          <p:nvPr/>
        </p:nvCxnSpPr>
        <p:spPr>
          <a:xfrm>
            <a:off x="10908661" y="3009375"/>
            <a:ext cx="0" cy="54032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F4039FB3-BFD5-A44B-A5F9-EE4DFB374230}"/>
              </a:ext>
            </a:extLst>
          </p:cNvPr>
          <p:cNvCxnSpPr>
            <a:cxnSpLocks/>
          </p:cNvCxnSpPr>
          <p:nvPr/>
        </p:nvCxnSpPr>
        <p:spPr>
          <a:xfrm>
            <a:off x="5724405" y="3092092"/>
            <a:ext cx="1" cy="47983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Graphic 50" descr="Ruler">
            <a:extLst>
              <a:ext uri="{FF2B5EF4-FFF2-40B4-BE49-F238E27FC236}">
                <a16:creationId xmlns:a16="http://schemas.microsoft.com/office/drawing/2014/main" id="{5AC48131-5ABE-3441-A000-4D8AB9F01A7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190282" y="3211710"/>
            <a:ext cx="433485" cy="433485"/>
          </a:xfrm>
          <a:prstGeom prst="rect">
            <a:avLst/>
          </a:prstGeom>
        </p:spPr>
      </p:pic>
      <p:pic>
        <p:nvPicPr>
          <p:cNvPr id="52" name="Graphic 51" descr="Ruler">
            <a:extLst>
              <a:ext uri="{FF2B5EF4-FFF2-40B4-BE49-F238E27FC236}">
                <a16:creationId xmlns:a16="http://schemas.microsoft.com/office/drawing/2014/main" id="{3AFDCAC0-FB2D-154E-A86D-9526CFC658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388717" y="3180005"/>
            <a:ext cx="433485" cy="433485"/>
          </a:xfrm>
          <a:prstGeom prst="rect">
            <a:avLst/>
          </a:prstGeom>
        </p:spPr>
      </p:pic>
      <p:pic>
        <p:nvPicPr>
          <p:cNvPr id="59" name="Graphic 58" descr="Footprint">
            <a:extLst>
              <a:ext uri="{FF2B5EF4-FFF2-40B4-BE49-F238E27FC236}">
                <a16:creationId xmlns:a16="http://schemas.microsoft.com/office/drawing/2014/main" id="{BBA944A3-2DDC-9C49-B365-07B99D55E6D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3915932" y="3204389"/>
            <a:ext cx="444156" cy="444156"/>
          </a:xfrm>
          <a:prstGeom prst="rect">
            <a:avLst/>
          </a:prstGeom>
        </p:spPr>
      </p:pic>
      <p:pic>
        <p:nvPicPr>
          <p:cNvPr id="60" name="Graphic 59" descr="Footprint">
            <a:extLst>
              <a:ext uri="{FF2B5EF4-FFF2-40B4-BE49-F238E27FC236}">
                <a16:creationId xmlns:a16="http://schemas.microsoft.com/office/drawing/2014/main" id="{FFC35515-4A0A-BA45-876E-C47DA8623A4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6444906" y="3205732"/>
            <a:ext cx="458362" cy="458362"/>
          </a:xfrm>
          <a:prstGeom prst="rect">
            <a:avLst/>
          </a:prstGeom>
        </p:spPr>
      </p:pic>
      <p:pic>
        <p:nvPicPr>
          <p:cNvPr id="61" name="Graphic 60" descr="Footprint">
            <a:extLst>
              <a:ext uri="{FF2B5EF4-FFF2-40B4-BE49-F238E27FC236}">
                <a16:creationId xmlns:a16="http://schemas.microsoft.com/office/drawing/2014/main" id="{B2E0EB0C-BD50-E54A-97DD-1C6C5FEE22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7942957" y="3207967"/>
            <a:ext cx="453893" cy="453893"/>
          </a:xfrm>
          <a:prstGeom prst="rect">
            <a:avLst/>
          </a:prstGeom>
        </p:spPr>
      </p:pic>
      <p:pic>
        <p:nvPicPr>
          <p:cNvPr id="62" name="Graphic 61" descr="Footprint">
            <a:extLst>
              <a:ext uri="{FF2B5EF4-FFF2-40B4-BE49-F238E27FC236}">
                <a16:creationId xmlns:a16="http://schemas.microsoft.com/office/drawing/2014/main" id="{31FF5B35-0894-2849-B13A-1C89A9A05BF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1295182" y="3207751"/>
            <a:ext cx="468245" cy="468245"/>
          </a:xfrm>
          <a:prstGeom prst="rect">
            <a:avLst/>
          </a:prstGeom>
        </p:spPr>
      </p:pic>
      <p:pic>
        <p:nvPicPr>
          <p:cNvPr id="63" name="Graphic 62" descr="Footprint">
            <a:extLst>
              <a:ext uri="{FF2B5EF4-FFF2-40B4-BE49-F238E27FC236}">
                <a16:creationId xmlns:a16="http://schemas.microsoft.com/office/drawing/2014/main" id="{581C59AD-B8F8-0943-9FA3-DC5B2A358CA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509325" y="3218244"/>
            <a:ext cx="406412" cy="40641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A687D870-F8B0-F542-B5FA-2DCB7396B3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4173" y="3218244"/>
            <a:ext cx="373656" cy="373656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34541DCE-DB93-E74C-9126-FFDFC27573B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43127" y="3225789"/>
            <a:ext cx="406507" cy="406507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C908246B-8155-4349-B7DD-32257AE74E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56962" y="3172972"/>
            <a:ext cx="449451" cy="449451"/>
          </a:xfrm>
          <a:prstGeom prst="rect">
            <a:avLst/>
          </a:prstGeom>
        </p:spPr>
      </p:pic>
      <p:pic>
        <p:nvPicPr>
          <p:cNvPr id="87" name="Graphic 86" descr="Footprint">
            <a:extLst>
              <a:ext uri="{FF2B5EF4-FFF2-40B4-BE49-F238E27FC236}">
                <a16:creationId xmlns:a16="http://schemas.microsoft.com/office/drawing/2014/main" id="{955123D4-E692-434C-8DE7-DABBF609D5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447597" y="3204389"/>
            <a:ext cx="444156" cy="44415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ED64A7F5-447E-3642-BD65-C971BCF743B2}"/>
              </a:ext>
            </a:extLst>
          </p:cNvPr>
          <p:cNvPicPr>
            <a:picLocks noChangeAspect="1"/>
          </p:cNvPicPr>
          <p:nvPr/>
        </p:nvPicPr>
        <p:blipFill>
          <a:blip r:embed="rId13">
            <a:biLevel thresh="50000"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18683" y="853351"/>
            <a:ext cx="521926" cy="712212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3794CB9C-1DC0-244B-A6B1-E8C6ED30BAC3}"/>
              </a:ext>
            </a:extLst>
          </p:cNvPr>
          <p:cNvPicPr>
            <a:picLocks noChangeAspect="1"/>
          </p:cNvPicPr>
          <p:nvPr/>
        </p:nvPicPr>
        <p:blipFill>
          <a:blip r:embed="rId14">
            <a:biLevel thresh="75000"/>
          </a:blip>
          <a:stretch>
            <a:fillRect/>
          </a:stretch>
        </p:blipFill>
        <p:spPr>
          <a:xfrm>
            <a:off x="7263517" y="853351"/>
            <a:ext cx="521926" cy="71221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AC0F2F7-080D-FD47-96C3-05E8349CBC7F}"/>
              </a:ext>
            </a:extLst>
          </p:cNvPr>
          <p:cNvPicPr>
            <a:picLocks noChangeAspect="1"/>
          </p:cNvPicPr>
          <p:nvPr/>
        </p:nvPicPr>
        <p:blipFill>
          <a:blip r:embed="rId15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5456271" y="919810"/>
            <a:ext cx="728971" cy="541188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B274A7D6-2BCB-854B-AAB8-A1CEA3BDB49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629347" y="1004852"/>
            <a:ext cx="435567" cy="435567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24269D80-8364-E144-8A13-316A6DFB1CE8}"/>
              </a:ext>
            </a:extLst>
          </p:cNvPr>
          <p:cNvPicPr>
            <a:picLocks noChangeAspect="1"/>
          </p:cNvPicPr>
          <p:nvPr/>
        </p:nvPicPr>
        <p:blipFill>
          <a:blip r:embed="rId13">
            <a:biLevel thresh="50000"/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76800" y="5054764"/>
            <a:ext cx="521926" cy="712212"/>
          </a:xfrm>
          <a:prstGeom prst="rect">
            <a:avLst/>
          </a:prstGeom>
        </p:spPr>
      </p:pic>
      <p:pic>
        <p:nvPicPr>
          <p:cNvPr id="97" name="Graphic 96" descr="Shopping cart">
            <a:extLst>
              <a:ext uri="{FF2B5EF4-FFF2-40B4-BE49-F238E27FC236}">
                <a16:creationId xmlns:a16="http://schemas.microsoft.com/office/drawing/2014/main" id="{28719FCE-1636-0245-A732-5304BC5D7FF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3270598" y="5063983"/>
            <a:ext cx="560347" cy="560347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834A74D9-52F4-E441-8F62-2FD4747E0AFA}"/>
              </a:ext>
            </a:extLst>
          </p:cNvPr>
          <p:cNvPicPr>
            <a:picLocks noChangeAspect="1"/>
          </p:cNvPicPr>
          <p:nvPr/>
        </p:nvPicPr>
        <p:blipFill>
          <a:blip r:embed="rId15">
            <a:duotone>
              <a:schemeClr val="accent4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3235334" y="5684407"/>
            <a:ext cx="728971" cy="541188"/>
          </a:xfrm>
          <a:prstGeom prst="rect">
            <a:avLst/>
          </a:prstGeom>
        </p:spPr>
      </p:pic>
      <p:pic>
        <p:nvPicPr>
          <p:cNvPr id="99" name="Graphic 98" descr="Plant">
            <a:extLst>
              <a:ext uri="{FF2B5EF4-FFF2-40B4-BE49-F238E27FC236}">
                <a16:creationId xmlns:a16="http://schemas.microsoft.com/office/drawing/2014/main" id="{94A95F93-6240-CE49-A316-7B3785254D2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3277525" y="6235567"/>
            <a:ext cx="515264" cy="515264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7DD31BC5-C250-5D4D-960E-FA7CE6C0E89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575112" y="6034792"/>
            <a:ext cx="381605" cy="381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776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93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g, Yu</dc:creator>
  <cp:lastModifiedBy>Meng, Yu</cp:lastModifiedBy>
  <cp:revision>17</cp:revision>
  <cp:lastPrinted>2018-06-26T18:24:21Z</cp:lastPrinted>
  <dcterms:created xsi:type="dcterms:W3CDTF">2018-06-26T17:10:13Z</dcterms:created>
  <dcterms:modified xsi:type="dcterms:W3CDTF">2018-06-28T18:48:23Z</dcterms:modified>
</cp:coreProperties>
</file>